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1" r:id="rId2"/>
    <p:sldId id="282" r:id="rId3"/>
    <p:sldId id="289" r:id="rId4"/>
    <p:sldId id="29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966AC16-4F0D-4962-86C5-6DBDDAFDA4D3}" v="27" dt="2023-09-13T15:52:49.91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 Abdulsalam (22175907)" userId="9d33f010-d780-4b66-8aa9-a6e52601067e" providerId="ADAL" clId="{D966AC16-4F0D-4962-86C5-6DBDDAFDA4D3}"/>
    <pc:docChg chg="undo custSel addSld delSld modSld">
      <pc:chgData name="R Abdulsalam (22175907)" userId="9d33f010-d780-4b66-8aa9-a6e52601067e" providerId="ADAL" clId="{D966AC16-4F0D-4962-86C5-6DBDDAFDA4D3}" dt="2023-09-13T15:54:15.585" v="1191" actId="14100"/>
      <pc:docMkLst>
        <pc:docMk/>
      </pc:docMkLst>
      <pc:sldChg chg="addSp delSp modSp mod">
        <pc:chgData name="R Abdulsalam (22175907)" userId="9d33f010-d780-4b66-8aa9-a6e52601067e" providerId="ADAL" clId="{D966AC16-4F0D-4962-86C5-6DBDDAFDA4D3}" dt="2023-09-13T13:10:34.736" v="221" actId="1036"/>
        <pc:sldMkLst>
          <pc:docMk/>
          <pc:sldMk cId="3571623030" sldId="256"/>
        </pc:sldMkLst>
        <pc:spChg chg="mod topLvl">
          <ac:chgData name="R Abdulsalam (22175907)" userId="9d33f010-d780-4b66-8aa9-a6e52601067e" providerId="ADAL" clId="{D966AC16-4F0D-4962-86C5-6DBDDAFDA4D3}" dt="2023-09-13T13:10:18.180" v="207" actId="164"/>
          <ac:spMkLst>
            <pc:docMk/>
            <pc:sldMk cId="3571623030" sldId="256"/>
            <ac:spMk id="2" creationId="{3C261582-86C1-AC18-08F0-B041B0740DC5}"/>
          </ac:spMkLst>
        </pc:spChg>
        <pc:grpChg chg="del">
          <ac:chgData name="R Abdulsalam (22175907)" userId="9d33f010-d780-4b66-8aa9-a6e52601067e" providerId="ADAL" clId="{D966AC16-4F0D-4962-86C5-6DBDDAFDA4D3}" dt="2023-09-13T13:09:33.656" v="102" actId="165"/>
          <ac:grpSpMkLst>
            <pc:docMk/>
            <pc:sldMk cId="3571623030" sldId="256"/>
            <ac:grpSpMk id="3" creationId="{0F945505-1416-5E3E-67EF-9FB68A70079C}"/>
          </ac:grpSpMkLst>
        </pc:grpChg>
        <pc:grpChg chg="add mod">
          <ac:chgData name="R Abdulsalam (22175907)" userId="9d33f010-d780-4b66-8aa9-a6e52601067e" providerId="ADAL" clId="{D966AC16-4F0D-4962-86C5-6DBDDAFDA4D3}" dt="2023-09-13T13:10:34.736" v="221" actId="1036"/>
          <ac:grpSpMkLst>
            <pc:docMk/>
            <pc:sldMk cId="3571623030" sldId="256"/>
            <ac:grpSpMk id="4" creationId="{F75252E8-E804-086F-DE74-2D49DD350777}"/>
          </ac:grpSpMkLst>
        </pc:grpChg>
        <pc:picChg chg="mod topLvl modCrop">
          <ac:chgData name="R Abdulsalam (22175907)" userId="9d33f010-d780-4b66-8aa9-a6e52601067e" providerId="ADAL" clId="{D966AC16-4F0D-4962-86C5-6DBDDAFDA4D3}" dt="2023-09-13T13:10:18.180" v="207" actId="164"/>
          <ac:picMkLst>
            <pc:docMk/>
            <pc:sldMk cId="3571623030" sldId="256"/>
            <ac:picMk id="7" creationId="{9E535C36-F43F-297F-8828-77D3722270A6}"/>
          </ac:picMkLst>
        </pc:picChg>
      </pc:sldChg>
      <pc:sldChg chg="addSp delSp modSp mod">
        <pc:chgData name="R Abdulsalam (22175907)" userId="9d33f010-d780-4b66-8aa9-a6e52601067e" providerId="ADAL" clId="{D966AC16-4F0D-4962-86C5-6DBDDAFDA4D3}" dt="2023-09-13T13:16:34.631" v="308" actId="1036"/>
        <pc:sldMkLst>
          <pc:docMk/>
          <pc:sldMk cId="1375426812" sldId="257"/>
        </pc:sldMkLst>
        <pc:spChg chg="mod topLvl">
          <ac:chgData name="R Abdulsalam (22175907)" userId="9d33f010-d780-4b66-8aa9-a6e52601067e" providerId="ADAL" clId="{D966AC16-4F0D-4962-86C5-6DBDDAFDA4D3}" dt="2023-09-13T13:16:31.727" v="307" actId="164"/>
          <ac:spMkLst>
            <pc:docMk/>
            <pc:sldMk cId="1375426812" sldId="257"/>
            <ac:spMk id="2" creationId="{0AA8B8B9-EFF5-FE5B-23FA-F71A13C3DEF6}"/>
          </ac:spMkLst>
        </pc:spChg>
        <pc:grpChg chg="del">
          <ac:chgData name="R Abdulsalam (22175907)" userId="9d33f010-d780-4b66-8aa9-a6e52601067e" providerId="ADAL" clId="{D966AC16-4F0D-4962-86C5-6DBDDAFDA4D3}" dt="2023-09-13T13:15:01.704" v="222" actId="165"/>
          <ac:grpSpMkLst>
            <pc:docMk/>
            <pc:sldMk cId="1375426812" sldId="257"/>
            <ac:grpSpMk id="4" creationId="{F7B4201C-78C3-B27D-B4C6-1630E3730908}"/>
          </ac:grpSpMkLst>
        </pc:grpChg>
        <pc:grpChg chg="add mod">
          <ac:chgData name="R Abdulsalam (22175907)" userId="9d33f010-d780-4b66-8aa9-a6e52601067e" providerId="ADAL" clId="{D966AC16-4F0D-4962-86C5-6DBDDAFDA4D3}" dt="2023-09-13T13:16:34.631" v="308" actId="1036"/>
          <ac:grpSpMkLst>
            <pc:docMk/>
            <pc:sldMk cId="1375426812" sldId="257"/>
            <ac:grpSpMk id="5" creationId="{8C67F14B-EAA5-1FE4-3E45-0BF9CA946B16}"/>
          </ac:grpSpMkLst>
        </pc:grpChg>
        <pc:picChg chg="mod topLvl modCrop">
          <ac:chgData name="R Abdulsalam (22175907)" userId="9d33f010-d780-4b66-8aa9-a6e52601067e" providerId="ADAL" clId="{D966AC16-4F0D-4962-86C5-6DBDDAFDA4D3}" dt="2023-09-13T13:16:31.727" v="307" actId="164"/>
          <ac:picMkLst>
            <pc:docMk/>
            <pc:sldMk cId="1375426812" sldId="257"/>
            <ac:picMk id="3" creationId="{26744E54-3AF2-9FF4-1DB2-E6D328736C22}"/>
          </ac:picMkLst>
        </pc:picChg>
      </pc:sldChg>
      <pc:sldChg chg="addSp delSp modSp mod">
        <pc:chgData name="R Abdulsalam (22175907)" userId="9d33f010-d780-4b66-8aa9-a6e52601067e" providerId="ADAL" clId="{D966AC16-4F0D-4962-86C5-6DBDDAFDA4D3}" dt="2023-09-13T13:25:01.919" v="440" actId="313"/>
        <pc:sldMkLst>
          <pc:docMk/>
          <pc:sldMk cId="373650891" sldId="258"/>
        </pc:sldMkLst>
        <pc:spChg chg="mod topLvl">
          <ac:chgData name="R Abdulsalam (22175907)" userId="9d33f010-d780-4b66-8aa9-a6e52601067e" providerId="ADAL" clId="{D966AC16-4F0D-4962-86C5-6DBDDAFDA4D3}" dt="2023-09-13T13:24:25.366" v="431" actId="2085"/>
          <ac:spMkLst>
            <pc:docMk/>
            <pc:sldMk cId="373650891" sldId="258"/>
            <ac:spMk id="3" creationId="{389D0DDB-9D8E-62C3-2BE3-9346BC3F0939}"/>
          </ac:spMkLst>
        </pc:spChg>
        <pc:spChg chg="mod">
          <ac:chgData name="R Abdulsalam (22175907)" userId="9d33f010-d780-4b66-8aa9-a6e52601067e" providerId="ADAL" clId="{D966AC16-4F0D-4962-86C5-6DBDDAFDA4D3}" dt="2023-09-13T13:25:01.919" v="440" actId="313"/>
          <ac:spMkLst>
            <pc:docMk/>
            <pc:sldMk cId="373650891" sldId="258"/>
            <ac:spMk id="9" creationId="{9983B97B-C493-5EA6-933B-1D6E391D2B5F}"/>
          </ac:spMkLst>
        </pc:spChg>
        <pc:grpChg chg="add mod">
          <ac:chgData name="R Abdulsalam (22175907)" userId="9d33f010-d780-4b66-8aa9-a6e52601067e" providerId="ADAL" clId="{D966AC16-4F0D-4962-86C5-6DBDDAFDA4D3}" dt="2023-09-13T13:24:48.420" v="439" actId="1036"/>
          <ac:grpSpMkLst>
            <pc:docMk/>
            <pc:sldMk cId="373650891" sldId="258"/>
            <ac:grpSpMk id="2" creationId="{2576260B-0712-C9A0-3B40-3F6E9097CFFA}"/>
          </ac:grpSpMkLst>
        </pc:grpChg>
        <pc:grpChg chg="del">
          <ac:chgData name="R Abdulsalam (22175907)" userId="9d33f010-d780-4b66-8aa9-a6e52601067e" providerId="ADAL" clId="{D966AC16-4F0D-4962-86C5-6DBDDAFDA4D3}" dt="2023-09-13T13:23:25.293" v="309" actId="165"/>
          <ac:grpSpMkLst>
            <pc:docMk/>
            <pc:sldMk cId="373650891" sldId="258"/>
            <ac:grpSpMk id="4" creationId="{13D6151D-D5D7-6DA6-D4AD-EEDE15E37287}"/>
          </ac:grpSpMkLst>
        </pc:grpChg>
        <pc:picChg chg="mod topLvl modCrop">
          <ac:chgData name="R Abdulsalam (22175907)" userId="9d33f010-d780-4b66-8aa9-a6e52601067e" providerId="ADAL" clId="{D966AC16-4F0D-4962-86C5-6DBDDAFDA4D3}" dt="2023-09-13T13:24:43.273" v="432" actId="732"/>
          <ac:picMkLst>
            <pc:docMk/>
            <pc:sldMk cId="373650891" sldId="258"/>
            <ac:picMk id="6" creationId="{C4AFD23C-BC2D-B19F-44BC-AC91A56F3D8F}"/>
          </ac:picMkLst>
        </pc:picChg>
      </pc:sldChg>
      <pc:sldChg chg="modSp mod">
        <pc:chgData name="R Abdulsalam (22175907)" userId="9d33f010-d780-4b66-8aa9-a6e52601067e" providerId="ADAL" clId="{D966AC16-4F0D-4962-86C5-6DBDDAFDA4D3}" dt="2023-09-13T13:29:52.489" v="617" actId="1036"/>
        <pc:sldMkLst>
          <pc:docMk/>
          <pc:sldMk cId="4200064058" sldId="270"/>
        </pc:sldMkLst>
        <pc:spChg chg="mod">
          <ac:chgData name="R Abdulsalam (22175907)" userId="9d33f010-d780-4b66-8aa9-a6e52601067e" providerId="ADAL" clId="{D966AC16-4F0D-4962-86C5-6DBDDAFDA4D3}" dt="2023-09-13T13:29:23.502" v="594" actId="2085"/>
          <ac:spMkLst>
            <pc:docMk/>
            <pc:sldMk cId="4200064058" sldId="270"/>
            <ac:spMk id="2" creationId="{7D0DC2CE-4E78-E4E8-5742-129B8692A0D9}"/>
          </ac:spMkLst>
        </pc:spChg>
        <pc:spChg chg="mod">
          <ac:chgData name="R Abdulsalam (22175907)" userId="9d33f010-d780-4b66-8aa9-a6e52601067e" providerId="ADAL" clId="{D966AC16-4F0D-4962-86C5-6DBDDAFDA4D3}" dt="2023-09-13T13:29:52.489" v="617" actId="1036"/>
          <ac:spMkLst>
            <pc:docMk/>
            <pc:sldMk cId="4200064058" sldId="270"/>
            <ac:spMk id="8" creationId="{FC620E92-710E-4BAB-5EBA-6E62C619FA2A}"/>
          </ac:spMkLst>
        </pc:spChg>
        <pc:grpChg chg="mod">
          <ac:chgData name="R Abdulsalam (22175907)" userId="9d33f010-d780-4b66-8aa9-a6e52601067e" providerId="ADAL" clId="{D966AC16-4F0D-4962-86C5-6DBDDAFDA4D3}" dt="2023-09-13T13:29:36.199" v="605" actId="1038"/>
          <ac:grpSpMkLst>
            <pc:docMk/>
            <pc:sldMk cId="4200064058" sldId="270"/>
            <ac:grpSpMk id="4" creationId="{073D03BE-AECD-02A2-228A-4AC200FA2E85}"/>
          </ac:grpSpMkLst>
        </pc:grpChg>
        <pc:picChg chg="mod modCrop">
          <ac:chgData name="R Abdulsalam (22175907)" userId="9d33f010-d780-4b66-8aa9-a6e52601067e" providerId="ADAL" clId="{D966AC16-4F0D-4962-86C5-6DBDDAFDA4D3}" dt="2023-09-13T13:29:16.272" v="593" actId="1582"/>
          <ac:picMkLst>
            <pc:docMk/>
            <pc:sldMk cId="4200064058" sldId="270"/>
            <ac:picMk id="3" creationId="{E7196E48-17EB-3265-4371-BC2749B00286}"/>
          </ac:picMkLst>
        </pc:picChg>
      </pc:sldChg>
      <pc:sldChg chg="addSp delSp modSp mod">
        <pc:chgData name="R Abdulsalam (22175907)" userId="9d33f010-d780-4b66-8aa9-a6e52601067e" providerId="ADAL" clId="{D966AC16-4F0D-4962-86C5-6DBDDAFDA4D3}" dt="2023-09-13T13:33:55.118" v="712" actId="164"/>
        <pc:sldMkLst>
          <pc:docMk/>
          <pc:sldMk cId="2008866088" sldId="271"/>
        </pc:sldMkLst>
        <pc:spChg chg="mod topLvl">
          <ac:chgData name="R Abdulsalam (22175907)" userId="9d33f010-d780-4b66-8aa9-a6e52601067e" providerId="ADAL" clId="{D966AC16-4F0D-4962-86C5-6DBDDAFDA4D3}" dt="2023-09-13T13:33:55.118" v="712" actId="164"/>
          <ac:spMkLst>
            <pc:docMk/>
            <pc:sldMk cId="2008866088" sldId="271"/>
            <ac:spMk id="2" creationId="{3760F225-93EC-F93F-5F61-FC698DC1162B}"/>
          </ac:spMkLst>
        </pc:spChg>
        <pc:grpChg chg="del">
          <ac:chgData name="R Abdulsalam (22175907)" userId="9d33f010-d780-4b66-8aa9-a6e52601067e" providerId="ADAL" clId="{D966AC16-4F0D-4962-86C5-6DBDDAFDA4D3}" dt="2023-09-13T13:32:35.850" v="618" actId="165"/>
          <ac:grpSpMkLst>
            <pc:docMk/>
            <pc:sldMk cId="2008866088" sldId="271"/>
            <ac:grpSpMk id="4" creationId="{2F0FE239-A8C6-CAE0-0166-38CB974BB467}"/>
          </ac:grpSpMkLst>
        </pc:grpChg>
        <pc:grpChg chg="add mod">
          <ac:chgData name="R Abdulsalam (22175907)" userId="9d33f010-d780-4b66-8aa9-a6e52601067e" providerId="ADAL" clId="{D966AC16-4F0D-4962-86C5-6DBDDAFDA4D3}" dt="2023-09-13T13:33:55.118" v="712" actId="164"/>
          <ac:grpSpMkLst>
            <pc:docMk/>
            <pc:sldMk cId="2008866088" sldId="271"/>
            <ac:grpSpMk id="5" creationId="{833C1181-DC85-BBC0-076C-77DCE68D8098}"/>
          </ac:grpSpMkLst>
        </pc:grpChg>
        <pc:picChg chg="mod topLvl modCrop">
          <ac:chgData name="R Abdulsalam (22175907)" userId="9d33f010-d780-4b66-8aa9-a6e52601067e" providerId="ADAL" clId="{D966AC16-4F0D-4962-86C5-6DBDDAFDA4D3}" dt="2023-09-13T13:33:55.118" v="712" actId="164"/>
          <ac:picMkLst>
            <pc:docMk/>
            <pc:sldMk cId="2008866088" sldId="271"/>
            <ac:picMk id="3" creationId="{91535CD0-1062-7D26-2DDC-85704E1EC0D2}"/>
          </ac:picMkLst>
        </pc:picChg>
      </pc:sldChg>
      <pc:sldChg chg="addSp delSp modSp mod">
        <pc:chgData name="R Abdulsalam (22175907)" userId="9d33f010-d780-4b66-8aa9-a6e52601067e" providerId="ADAL" clId="{D966AC16-4F0D-4962-86C5-6DBDDAFDA4D3}" dt="2023-09-13T13:37:37.811" v="789" actId="164"/>
        <pc:sldMkLst>
          <pc:docMk/>
          <pc:sldMk cId="3594634406" sldId="272"/>
        </pc:sldMkLst>
        <pc:spChg chg="mod topLvl">
          <ac:chgData name="R Abdulsalam (22175907)" userId="9d33f010-d780-4b66-8aa9-a6e52601067e" providerId="ADAL" clId="{D966AC16-4F0D-4962-86C5-6DBDDAFDA4D3}" dt="2023-09-13T13:37:37.811" v="789" actId="164"/>
          <ac:spMkLst>
            <pc:docMk/>
            <pc:sldMk cId="3594634406" sldId="272"/>
            <ac:spMk id="2" creationId="{214BF476-EBFE-2B16-8B31-F532CA44B214}"/>
          </ac:spMkLst>
        </pc:spChg>
        <pc:grpChg chg="del">
          <ac:chgData name="R Abdulsalam (22175907)" userId="9d33f010-d780-4b66-8aa9-a6e52601067e" providerId="ADAL" clId="{D966AC16-4F0D-4962-86C5-6DBDDAFDA4D3}" dt="2023-09-13T13:36:30.538" v="713" actId="165"/>
          <ac:grpSpMkLst>
            <pc:docMk/>
            <pc:sldMk cId="3594634406" sldId="272"/>
            <ac:grpSpMk id="4" creationId="{CF028A1A-AA73-177B-2F57-3F6523640BD6}"/>
          </ac:grpSpMkLst>
        </pc:grpChg>
        <pc:grpChg chg="add mod">
          <ac:chgData name="R Abdulsalam (22175907)" userId="9d33f010-d780-4b66-8aa9-a6e52601067e" providerId="ADAL" clId="{D966AC16-4F0D-4962-86C5-6DBDDAFDA4D3}" dt="2023-09-13T13:37:37.811" v="789" actId="164"/>
          <ac:grpSpMkLst>
            <pc:docMk/>
            <pc:sldMk cId="3594634406" sldId="272"/>
            <ac:grpSpMk id="5" creationId="{5A3BC55E-CF71-724E-8094-843D64A55D7E}"/>
          </ac:grpSpMkLst>
        </pc:grpChg>
        <pc:picChg chg="mod topLvl modCrop">
          <ac:chgData name="R Abdulsalam (22175907)" userId="9d33f010-d780-4b66-8aa9-a6e52601067e" providerId="ADAL" clId="{D966AC16-4F0D-4962-86C5-6DBDDAFDA4D3}" dt="2023-09-13T13:37:37.811" v="789" actId="164"/>
          <ac:picMkLst>
            <pc:docMk/>
            <pc:sldMk cId="3594634406" sldId="272"/>
            <ac:picMk id="3" creationId="{B1E1B590-5AA3-98D0-CBBD-953299B57103}"/>
          </ac:picMkLst>
        </pc:picChg>
      </pc:sldChg>
      <pc:sldChg chg="addSp delSp modSp mod">
        <pc:chgData name="R Abdulsalam (22175907)" userId="9d33f010-d780-4b66-8aa9-a6e52601067e" providerId="ADAL" clId="{D966AC16-4F0D-4962-86C5-6DBDDAFDA4D3}" dt="2023-09-13T13:41:20.845" v="889" actId="1036"/>
        <pc:sldMkLst>
          <pc:docMk/>
          <pc:sldMk cId="2839979194" sldId="273"/>
        </pc:sldMkLst>
        <pc:spChg chg="mod topLvl">
          <ac:chgData name="R Abdulsalam (22175907)" userId="9d33f010-d780-4b66-8aa9-a6e52601067e" providerId="ADAL" clId="{D966AC16-4F0D-4962-86C5-6DBDDAFDA4D3}" dt="2023-09-13T13:41:17.571" v="886" actId="164"/>
          <ac:spMkLst>
            <pc:docMk/>
            <pc:sldMk cId="2839979194" sldId="273"/>
            <ac:spMk id="2" creationId="{57752309-4269-5B38-301B-888E11C7FF76}"/>
          </ac:spMkLst>
        </pc:spChg>
        <pc:grpChg chg="del">
          <ac:chgData name="R Abdulsalam (22175907)" userId="9d33f010-d780-4b66-8aa9-a6e52601067e" providerId="ADAL" clId="{D966AC16-4F0D-4962-86C5-6DBDDAFDA4D3}" dt="2023-09-13T13:40:02.803" v="791" actId="165"/>
          <ac:grpSpMkLst>
            <pc:docMk/>
            <pc:sldMk cId="2839979194" sldId="273"/>
            <ac:grpSpMk id="4" creationId="{7F239124-6FC0-B029-4AD7-79A0E904B99B}"/>
          </ac:grpSpMkLst>
        </pc:grpChg>
        <pc:grpChg chg="add mod">
          <ac:chgData name="R Abdulsalam (22175907)" userId="9d33f010-d780-4b66-8aa9-a6e52601067e" providerId="ADAL" clId="{D966AC16-4F0D-4962-86C5-6DBDDAFDA4D3}" dt="2023-09-13T13:41:20.845" v="889" actId="1036"/>
          <ac:grpSpMkLst>
            <pc:docMk/>
            <pc:sldMk cId="2839979194" sldId="273"/>
            <ac:grpSpMk id="5" creationId="{3B7EBEF9-377D-C47C-1006-BEC054D1B02E}"/>
          </ac:grpSpMkLst>
        </pc:grpChg>
        <pc:picChg chg="mod topLvl modCrop">
          <ac:chgData name="R Abdulsalam (22175907)" userId="9d33f010-d780-4b66-8aa9-a6e52601067e" providerId="ADAL" clId="{D966AC16-4F0D-4962-86C5-6DBDDAFDA4D3}" dt="2023-09-13T13:41:17.571" v="886" actId="164"/>
          <ac:picMkLst>
            <pc:docMk/>
            <pc:sldMk cId="2839979194" sldId="273"/>
            <ac:picMk id="3" creationId="{63AE2B85-1FAC-3D67-41F0-7E90DF7209D8}"/>
          </ac:picMkLst>
        </pc:picChg>
      </pc:sldChg>
      <pc:sldChg chg="addSp delSp modSp mod">
        <pc:chgData name="R Abdulsalam (22175907)" userId="9d33f010-d780-4b66-8aa9-a6e52601067e" providerId="ADAL" clId="{D966AC16-4F0D-4962-86C5-6DBDDAFDA4D3}" dt="2023-09-13T13:45:15.345" v="983" actId="164"/>
        <pc:sldMkLst>
          <pc:docMk/>
          <pc:sldMk cId="2880761456" sldId="274"/>
        </pc:sldMkLst>
        <pc:spChg chg="mod topLvl">
          <ac:chgData name="R Abdulsalam (22175907)" userId="9d33f010-d780-4b66-8aa9-a6e52601067e" providerId="ADAL" clId="{D966AC16-4F0D-4962-86C5-6DBDDAFDA4D3}" dt="2023-09-13T13:45:15.345" v="983" actId="164"/>
          <ac:spMkLst>
            <pc:docMk/>
            <pc:sldMk cId="2880761456" sldId="274"/>
            <ac:spMk id="2" creationId="{8DAAF0B8-B68D-B67F-181D-EDD19DC8B754}"/>
          </ac:spMkLst>
        </pc:spChg>
        <pc:grpChg chg="del">
          <ac:chgData name="R Abdulsalam (22175907)" userId="9d33f010-d780-4b66-8aa9-a6e52601067e" providerId="ADAL" clId="{D966AC16-4F0D-4962-86C5-6DBDDAFDA4D3}" dt="2023-09-13T13:44:12.446" v="890" actId="165"/>
          <ac:grpSpMkLst>
            <pc:docMk/>
            <pc:sldMk cId="2880761456" sldId="274"/>
            <ac:grpSpMk id="4" creationId="{0B7AE184-FA3E-CEC8-931D-E1BC47EEAF69}"/>
          </ac:grpSpMkLst>
        </pc:grpChg>
        <pc:grpChg chg="add mod">
          <ac:chgData name="R Abdulsalam (22175907)" userId="9d33f010-d780-4b66-8aa9-a6e52601067e" providerId="ADAL" clId="{D966AC16-4F0D-4962-86C5-6DBDDAFDA4D3}" dt="2023-09-13T13:45:15.345" v="983" actId="164"/>
          <ac:grpSpMkLst>
            <pc:docMk/>
            <pc:sldMk cId="2880761456" sldId="274"/>
            <ac:grpSpMk id="5" creationId="{4CC2540F-815D-CE07-9554-DA7DA8FEC3D5}"/>
          </ac:grpSpMkLst>
        </pc:grpChg>
        <pc:picChg chg="mod topLvl modCrop">
          <ac:chgData name="R Abdulsalam (22175907)" userId="9d33f010-d780-4b66-8aa9-a6e52601067e" providerId="ADAL" clId="{D966AC16-4F0D-4962-86C5-6DBDDAFDA4D3}" dt="2023-09-13T13:45:15.345" v="983" actId="164"/>
          <ac:picMkLst>
            <pc:docMk/>
            <pc:sldMk cId="2880761456" sldId="274"/>
            <ac:picMk id="3" creationId="{0F16D77C-72F8-0C22-D901-A937D0B16284}"/>
          </ac:picMkLst>
        </pc:picChg>
      </pc:sldChg>
      <pc:sldChg chg="addSp delSp modSp mod">
        <pc:chgData name="R Abdulsalam (22175907)" userId="9d33f010-d780-4b66-8aa9-a6e52601067e" providerId="ADAL" clId="{D966AC16-4F0D-4962-86C5-6DBDDAFDA4D3}" dt="2023-09-13T13:48:39.223" v="1012" actId="164"/>
        <pc:sldMkLst>
          <pc:docMk/>
          <pc:sldMk cId="1045171408" sldId="275"/>
        </pc:sldMkLst>
        <pc:spChg chg="mod topLvl">
          <ac:chgData name="R Abdulsalam (22175907)" userId="9d33f010-d780-4b66-8aa9-a6e52601067e" providerId="ADAL" clId="{D966AC16-4F0D-4962-86C5-6DBDDAFDA4D3}" dt="2023-09-13T13:48:39.223" v="1012" actId="164"/>
          <ac:spMkLst>
            <pc:docMk/>
            <pc:sldMk cId="1045171408" sldId="275"/>
            <ac:spMk id="2" creationId="{9866370C-DC0E-0136-A052-61F162B443CD}"/>
          </ac:spMkLst>
        </pc:spChg>
        <pc:grpChg chg="del mod">
          <ac:chgData name="R Abdulsalam (22175907)" userId="9d33f010-d780-4b66-8aa9-a6e52601067e" providerId="ADAL" clId="{D966AC16-4F0D-4962-86C5-6DBDDAFDA4D3}" dt="2023-09-13T13:47:44.528" v="985" actId="165"/>
          <ac:grpSpMkLst>
            <pc:docMk/>
            <pc:sldMk cId="1045171408" sldId="275"/>
            <ac:grpSpMk id="4" creationId="{1FBD56F2-F2A5-3B52-0682-D2D4DF899AD6}"/>
          </ac:grpSpMkLst>
        </pc:grpChg>
        <pc:grpChg chg="add mod">
          <ac:chgData name="R Abdulsalam (22175907)" userId="9d33f010-d780-4b66-8aa9-a6e52601067e" providerId="ADAL" clId="{D966AC16-4F0D-4962-86C5-6DBDDAFDA4D3}" dt="2023-09-13T13:48:39.223" v="1012" actId="164"/>
          <ac:grpSpMkLst>
            <pc:docMk/>
            <pc:sldMk cId="1045171408" sldId="275"/>
            <ac:grpSpMk id="5" creationId="{2E8197BA-214F-6D72-4E5D-414483CF6A8C}"/>
          </ac:grpSpMkLst>
        </pc:grpChg>
        <pc:picChg chg="mod topLvl modCrop">
          <ac:chgData name="R Abdulsalam (22175907)" userId="9d33f010-d780-4b66-8aa9-a6e52601067e" providerId="ADAL" clId="{D966AC16-4F0D-4962-86C5-6DBDDAFDA4D3}" dt="2023-09-13T13:48:39.223" v="1012" actId="164"/>
          <ac:picMkLst>
            <pc:docMk/>
            <pc:sldMk cId="1045171408" sldId="275"/>
            <ac:picMk id="3" creationId="{8F7E4CC1-9043-73C5-BB68-07F65F51547F}"/>
          </ac:picMkLst>
        </pc:picChg>
      </pc:sldChg>
      <pc:sldChg chg="addSp delSp modSp mod">
        <pc:chgData name="R Abdulsalam (22175907)" userId="9d33f010-d780-4b66-8aa9-a6e52601067e" providerId="ADAL" clId="{D966AC16-4F0D-4962-86C5-6DBDDAFDA4D3}" dt="2023-09-13T13:53:46.815" v="1020" actId="164"/>
        <pc:sldMkLst>
          <pc:docMk/>
          <pc:sldMk cId="1946271716" sldId="276"/>
        </pc:sldMkLst>
        <pc:spChg chg="mod topLvl">
          <ac:chgData name="R Abdulsalam (22175907)" userId="9d33f010-d780-4b66-8aa9-a6e52601067e" providerId="ADAL" clId="{D966AC16-4F0D-4962-86C5-6DBDDAFDA4D3}" dt="2023-09-13T13:53:46.815" v="1020" actId="164"/>
          <ac:spMkLst>
            <pc:docMk/>
            <pc:sldMk cId="1946271716" sldId="276"/>
            <ac:spMk id="2" creationId="{E88D92B8-75E0-37EA-E0E0-6673305ECD85}"/>
          </ac:spMkLst>
        </pc:spChg>
        <pc:grpChg chg="del">
          <ac:chgData name="R Abdulsalam (22175907)" userId="9d33f010-d780-4b66-8aa9-a6e52601067e" providerId="ADAL" clId="{D966AC16-4F0D-4962-86C5-6DBDDAFDA4D3}" dt="2023-09-13T13:52:23.579" v="1013" actId="165"/>
          <ac:grpSpMkLst>
            <pc:docMk/>
            <pc:sldMk cId="1946271716" sldId="276"/>
            <ac:grpSpMk id="4" creationId="{48F8A312-E7F2-BF9C-6473-491626537F40}"/>
          </ac:grpSpMkLst>
        </pc:grpChg>
        <pc:grpChg chg="add mod">
          <ac:chgData name="R Abdulsalam (22175907)" userId="9d33f010-d780-4b66-8aa9-a6e52601067e" providerId="ADAL" clId="{D966AC16-4F0D-4962-86C5-6DBDDAFDA4D3}" dt="2023-09-13T13:53:46.815" v="1020" actId="164"/>
          <ac:grpSpMkLst>
            <pc:docMk/>
            <pc:sldMk cId="1946271716" sldId="276"/>
            <ac:grpSpMk id="5" creationId="{A11FE917-B3B9-0D67-C266-03059EB8DE3B}"/>
          </ac:grpSpMkLst>
        </pc:grpChg>
        <pc:picChg chg="mod topLvl modCrop">
          <ac:chgData name="R Abdulsalam (22175907)" userId="9d33f010-d780-4b66-8aa9-a6e52601067e" providerId="ADAL" clId="{D966AC16-4F0D-4962-86C5-6DBDDAFDA4D3}" dt="2023-09-13T13:53:46.815" v="1020" actId="164"/>
          <ac:picMkLst>
            <pc:docMk/>
            <pc:sldMk cId="1946271716" sldId="276"/>
            <ac:picMk id="3" creationId="{98462B78-4D49-E979-0792-72D55AF2009F}"/>
          </ac:picMkLst>
        </pc:picChg>
      </pc:sldChg>
      <pc:sldChg chg="modSp mod">
        <pc:chgData name="R Abdulsalam (22175907)" userId="9d33f010-d780-4b66-8aa9-a6e52601067e" providerId="ADAL" clId="{D966AC16-4F0D-4962-86C5-6DBDDAFDA4D3}" dt="2023-09-13T14:36:58.924" v="1026" actId="1076"/>
        <pc:sldMkLst>
          <pc:docMk/>
          <pc:sldMk cId="3216520538" sldId="290"/>
        </pc:sldMkLst>
        <pc:picChg chg="mod">
          <ac:chgData name="R Abdulsalam (22175907)" userId="9d33f010-d780-4b66-8aa9-a6e52601067e" providerId="ADAL" clId="{D966AC16-4F0D-4962-86C5-6DBDDAFDA4D3}" dt="2023-09-13T14:36:58.924" v="1026" actId="1076"/>
          <ac:picMkLst>
            <pc:docMk/>
            <pc:sldMk cId="3216520538" sldId="290"/>
            <ac:picMk id="8" creationId="{584A2663-C666-64AE-E904-32FB038177C0}"/>
          </ac:picMkLst>
        </pc:picChg>
      </pc:sldChg>
      <pc:sldChg chg="new del">
        <pc:chgData name="R Abdulsalam (22175907)" userId="9d33f010-d780-4b66-8aa9-a6e52601067e" providerId="ADAL" clId="{D966AC16-4F0D-4962-86C5-6DBDDAFDA4D3}" dt="2023-09-13T15:45:25.707" v="1028" actId="680"/>
        <pc:sldMkLst>
          <pc:docMk/>
          <pc:sldMk cId="1233878072" sldId="291"/>
        </pc:sldMkLst>
      </pc:sldChg>
      <pc:sldChg chg="addSp delSp modSp new mod setBg setFolMasterObjs">
        <pc:chgData name="R Abdulsalam (22175907)" userId="9d33f010-d780-4b66-8aa9-a6e52601067e" providerId="ADAL" clId="{D966AC16-4F0D-4962-86C5-6DBDDAFDA4D3}" dt="2023-09-13T15:54:15.585" v="1191" actId="14100"/>
        <pc:sldMkLst>
          <pc:docMk/>
          <pc:sldMk cId="1530533052" sldId="291"/>
        </pc:sldMkLst>
        <pc:spChg chg="add mod">
          <ac:chgData name="R Abdulsalam (22175907)" userId="9d33f010-d780-4b66-8aa9-a6e52601067e" providerId="ADAL" clId="{D966AC16-4F0D-4962-86C5-6DBDDAFDA4D3}" dt="2023-09-13T15:53:27.973" v="1093" actId="1037"/>
          <ac:spMkLst>
            <pc:docMk/>
            <pc:sldMk cId="1530533052" sldId="291"/>
            <ac:spMk id="9" creationId="{71567431-4E61-9EB4-81C9-88477A20AE7E}"/>
          </ac:spMkLst>
        </pc:spChg>
        <pc:spChg chg="add mod">
          <ac:chgData name="R Abdulsalam (22175907)" userId="9d33f010-d780-4b66-8aa9-a6e52601067e" providerId="ADAL" clId="{D966AC16-4F0D-4962-86C5-6DBDDAFDA4D3}" dt="2023-09-13T15:54:15.585" v="1191" actId="14100"/>
          <ac:spMkLst>
            <pc:docMk/>
            <pc:sldMk cId="1530533052" sldId="291"/>
            <ac:spMk id="11" creationId="{A20F7B9A-C8F1-2CAD-C51A-689D4CF94E94}"/>
          </ac:spMkLst>
        </pc:spChg>
        <pc:spChg chg="add del">
          <ac:chgData name="R Abdulsalam (22175907)" userId="9d33f010-d780-4b66-8aa9-a6e52601067e" providerId="ADAL" clId="{D966AC16-4F0D-4962-86C5-6DBDDAFDA4D3}" dt="2023-09-13T15:51:52.678" v="1069" actId="26606"/>
          <ac:spMkLst>
            <pc:docMk/>
            <pc:sldMk cId="1530533052" sldId="291"/>
            <ac:spMk id="13" creationId="{F3060C83-F051-4F0E-ABAD-AA0DFC48B218}"/>
          </ac:spMkLst>
        </pc:spChg>
        <pc:spChg chg="add del">
          <ac:chgData name="R Abdulsalam (22175907)" userId="9d33f010-d780-4b66-8aa9-a6e52601067e" providerId="ADAL" clId="{D966AC16-4F0D-4962-86C5-6DBDDAFDA4D3}" dt="2023-09-13T15:51:52.678" v="1069" actId="26606"/>
          <ac:spMkLst>
            <pc:docMk/>
            <pc:sldMk cId="1530533052" sldId="291"/>
            <ac:spMk id="15" creationId="{83C98ABE-055B-441F-B07E-44F97F083C39}"/>
          </ac:spMkLst>
        </pc:spChg>
        <pc:spChg chg="add del">
          <ac:chgData name="R Abdulsalam (22175907)" userId="9d33f010-d780-4b66-8aa9-a6e52601067e" providerId="ADAL" clId="{D966AC16-4F0D-4962-86C5-6DBDDAFDA4D3}" dt="2023-09-13T15:51:52.678" v="1069" actId="26606"/>
          <ac:spMkLst>
            <pc:docMk/>
            <pc:sldMk cId="1530533052" sldId="291"/>
            <ac:spMk id="17" creationId="{29FDB030-9B49-4CED-8CCD-4D99382388AC}"/>
          </ac:spMkLst>
        </pc:spChg>
        <pc:spChg chg="add del">
          <ac:chgData name="R Abdulsalam (22175907)" userId="9d33f010-d780-4b66-8aa9-a6e52601067e" providerId="ADAL" clId="{D966AC16-4F0D-4962-86C5-6DBDDAFDA4D3}" dt="2023-09-13T15:51:52.678" v="1069" actId="26606"/>
          <ac:spMkLst>
            <pc:docMk/>
            <pc:sldMk cId="1530533052" sldId="291"/>
            <ac:spMk id="19" creationId="{3783CA14-24A1-485C-8B30-D6A5D87987AD}"/>
          </ac:spMkLst>
        </pc:spChg>
        <pc:spChg chg="add del">
          <ac:chgData name="R Abdulsalam (22175907)" userId="9d33f010-d780-4b66-8aa9-a6e52601067e" providerId="ADAL" clId="{D966AC16-4F0D-4962-86C5-6DBDDAFDA4D3}" dt="2023-09-13T15:51:52.678" v="1069" actId="26606"/>
          <ac:spMkLst>
            <pc:docMk/>
            <pc:sldMk cId="1530533052" sldId="291"/>
            <ac:spMk id="21" creationId="{9A97C86A-04D6-40F7-AE84-31AB43E6A846}"/>
          </ac:spMkLst>
        </pc:spChg>
        <pc:spChg chg="add del">
          <ac:chgData name="R Abdulsalam (22175907)" userId="9d33f010-d780-4b66-8aa9-a6e52601067e" providerId="ADAL" clId="{D966AC16-4F0D-4962-86C5-6DBDDAFDA4D3}" dt="2023-09-13T15:51:52.678" v="1069" actId="26606"/>
          <ac:spMkLst>
            <pc:docMk/>
            <pc:sldMk cId="1530533052" sldId="291"/>
            <ac:spMk id="23" creationId="{FF9F2414-84E8-453E-B1F3-389FDE8192D9}"/>
          </ac:spMkLst>
        </pc:spChg>
        <pc:spChg chg="add del">
          <ac:chgData name="R Abdulsalam (22175907)" userId="9d33f010-d780-4b66-8aa9-a6e52601067e" providerId="ADAL" clId="{D966AC16-4F0D-4962-86C5-6DBDDAFDA4D3}" dt="2023-09-13T15:51:52.678" v="1069" actId="26606"/>
          <ac:spMkLst>
            <pc:docMk/>
            <pc:sldMk cId="1530533052" sldId="291"/>
            <ac:spMk id="25" creationId="{3ECA69A1-7536-43AC-85EF-C7106179F5ED}"/>
          </ac:spMkLst>
        </pc:spChg>
        <pc:spChg chg="add del">
          <ac:chgData name="R Abdulsalam (22175907)" userId="9d33f010-d780-4b66-8aa9-a6e52601067e" providerId="ADAL" clId="{D966AC16-4F0D-4962-86C5-6DBDDAFDA4D3}" dt="2023-09-13T15:52:32.034" v="1071" actId="26606"/>
          <ac:spMkLst>
            <pc:docMk/>
            <pc:sldMk cId="1530533052" sldId="291"/>
            <ac:spMk id="27" creationId="{2D2B266D-3625-4584-A5C3-7D3F672CFF30}"/>
          </ac:spMkLst>
        </pc:spChg>
        <pc:spChg chg="add del">
          <ac:chgData name="R Abdulsalam (22175907)" userId="9d33f010-d780-4b66-8aa9-a6e52601067e" providerId="ADAL" clId="{D966AC16-4F0D-4962-86C5-6DBDDAFDA4D3}" dt="2023-09-13T15:52:32.034" v="1071" actId="26606"/>
          <ac:spMkLst>
            <pc:docMk/>
            <pc:sldMk cId="1530533052" sldId="291"/>
            <ac:spMk id="28" creationId="{C463B99A-73EE-4FBB-B7C4-F9F9BCC25C65}"/>
          </ac:spMkLst>
        </pc:spChg>
        <pc:spChg chg="add del">
          <ac:chgData name="R Abdulsalam (22175907)" userId="9d33f010-d780-4b66-8aa9-a6e52601067e" providerId="ADAL" clId="{D966AC16-4F0D-4962-86C5-6DBDDAFDA4D3}" dt="2023-09-13T15:52:32.034" v="1071" actId="26606"/>
          <ac:spMkLst>
            <pc:docMk/>
            <pc:sldMk cId="1530533052" sldId="291"/>
            <ac:spMk id="29" creationId="{A5D2A5D1-BA0D-47D3-B051-DA7743C46E28}"/>
          </ac:spMkLst>
        </pc:spChg>
        <pc:graphicFrameChg chg="add del modGraphic">
          <ac:chgData name="R Abdulsalam (22175907)" userId="9d33f010-d780-4b66-8aa9-a6e52601067e" providerId="ADAL" clId="{D966AC16-4F0D-4962-86C5-6DBDDAFDA4D3}" dt="2023-09-13T15:48:04.519" v="1035" actId="3680"/>
          <ac:graphicFrameMkLst>
            <pc:docMk/>
            <pc:sldMk cId="1530533052" sldId="291"/>
            <ac:graphicFrameMk id="3" creationId="{6306EC4C-A196-D648-8173-8D6484D58702}"/>
          </ac:graphicFrameMkLst>
        </pc:graphicFrameChg>
        <pc:graphicFrameChg chg="add del mod">
          <ac:chgData name="R Abdulsalam (22175907)" userId="9d33f010-d780-4b66-8aa9-a6e52601067e" providerId="ADAL" clId="{D966AC16-4F0D-4962-86C5-6DBDDAFDA4D3}" dt="2023-09-13T15:50:24.239" v="1041"/>
          <ac:graphicFrameMkLst>
            <pc:docMk/>
            <pc:sldMk cId="1530533052" sldId="291"/>
            <ac:graphicFrameMk id="6" creationId="{B389961D-326E-D1FA-E442-E414D5342C29}"/>
          </ac:graphicFrameMkLst>
        </pc:graphicFrameChg>
        <pc:graphicFrameChg chg="add del mod modGraphic">
          <ac:chgData name="R Abdulsalam (22175907)" userId="9d33f010-d780-4b66-8aa9-a6e52601067e" providerId="ADAL" clId="{D966AC16-4F0D-4962-86C5-6DBDDAFDA4D3}" dt="2023-09-13T15:51:15.376" v="1046" actId="478"/>
          <ac:graphicFrameMkLst>
            <pc:docMk/>
            <pc:sldMk cId="1530533052" sldId="291"/>
            <ac:graphicFrameMk id="7" creationId="{65C7F892-AD68-E718-30E9-6A4D4F50B214}"/>
          </ac:graphicFrameMkLst>
        </pc:graphicFrameChg>
        <pc:graphicFrameChg chg="add mod modGraphic">
          <ac:chgData name="R Abdulsalam (22175907)" userId="9d33f010-d780-4b66-8aa9-a6e52601067e" providerId="ADAL" clId="{D966AC16-4F0D-4962-86C5-6DBDDAFDA4D3}" dt="2023-09-13T15:52:32.034" v="1071" actId="26606"/>
          <ac:graphicFrameMkLst>
            <pc:docMk/>
            <pc:sldMk cId="1530533052" sldId="291"/>
            <ac:graphicFrameMk id="8" creationId="{EFCBE9DD-3675-A147-7FD9-1A04108A17FB}"/>
          </ac:graphicFrameMkLst>
        </pc:graphicFrameChg>
        <pc:picChg chg="add del">
          <ac:chgData name="R Abdulsalam (22175907)" userId="9d33f010-d780-4b66-8aa9-a6e52601067e" providerId="ADAL" clId="{D966AC16-4F0D-4962-86C5-6DBDDAFDA4D3}" dt="2023-09-13T15:46:08.090" v="1031"/>
          <ac:picMkLst>
            <pc:docMk/>
            <pc:sldMk cId="1530533052" sldId="291"/>
            <ac:picMk id="2" creationId="{741FF14F-5585-7798-A443-74F3260A83E2}"/>
          </ac:picMkLst>
        </pc:picChg>
        <pc:picChg chg="add del mod">
          <ac:chgData name="R Abdulsalam (22175907)" userId="9d33f010-d780-4b66-8aa9-a6e52601067e" providerId="ADAL" clId="{D966AC16-4F0D-4962-86C5-6DBDDAFDA4D3}" dt="2023-09-13T15:49:46.248" v="1039" actId="478"/>
          <ac:picMkLst>
            <pc:docMk/>
            <pc:sldMk cId="1530533052" sldId="291"/>
            <ac:picMk id="5" creationId="{98923BE1-AA31-595C-E2D8-B198FCEF510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CEC420-695F-4004-9328-009FF7439FC4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E6608C-461B-49DE-93EF-A25FC8DE56F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99945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C0CF99-1822-C24B-92A7-A42320E3BC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4783CB-8076-B1E8-3AA9-D1705D6AF3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C10741-F41D-D75B-55F8-B85895327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B8253F-1835-1EBC-8EEF-33419DDA0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BAFCEA-A95C-C3D3-343D-81C4AEAAC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40170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29829-000A-753E-88D3-B956EC2AAA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1BADA0-CE8A-C0DE-8DEE-C8CF6D9C85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6D9EEE-BFFE-F91A-E93C-E26D987F51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C431A1-C656-6A38-36A0-C2457B368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CEE75C-5E4C-4E63-0ED8-6323AC8C3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09896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407FD48-B997-5E67-20A0-5E6363E803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B604AB-716E-7A7C-3219-E97D21C577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61EF4F-A085-5356-52CD-09AC62B3D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627B10-3586-EDF8-542A-10CD1EC7C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AADF99-82E5-0E57-4205-04329BBDA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4792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A12E3E-0154-37AC-DB80-A6B4FC5AE6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11CE53-2C8E-4C00-26DD-124DD8B14E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B2631C-2112-75BA-0F97-7CF2BF939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BCE46B-4390-9E79-001F-850700F2AD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C0B11C-B7CC-6861-357E-6E2400B7F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63041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3F404-44B7-B362-80AA-C90F2201A9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F076A4-BE1C-F2E6-F406-88C6BF567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48ED23-457F-84D3-84FE-07BB22D8F8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8346E3-315F-86CE-954B-50DE89F7D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2F0178-2202-E893-DA5F-64419697F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10965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0CD71E-F7D8-55F0-9A22-86207DE55F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207136-34F4-8D76-B206-407C4B305F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DBF2B0-AF22-9261-C55C-5E223E427E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2AFD61-151E-482F-AEE6-4F87313C8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B2CEB7-F8C8-8F54-F641-A0D26D059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7CCEC1-FACE-C490-D610-1DE32FF95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80287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1D2891-EC2A-DAB4-FDEC-E42BA89AAB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C06198-D748-8811-5B2F-AAEB0EEBA9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E3EC9A-B847-36A2-C386-874A831D2E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7693879-1623-6768-D007-B7F29934A8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FB9331-CACC-BB31-46A5-70F93179B6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BF1B09-B459-C9C6-779A-6BE6A8F75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568BA4-714B-ABF8-EF4E-84DA863CA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8DFFC2-3E39-EE46-A256-030EE97C8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64143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53DCE1-EB58-A64C-EDAC-79AEFD2BCD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B6BE23E-9B36-F4DA-D541-EE8E58058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E10EBF-4C19-7E60-FE6A-60836CD41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164EFC-BCDD-D457-531F-4E712A262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14719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AFACEE-82D7-C11B-7D10-CD42DF649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770F68-176E-3E00-85B8-DE6FD0FFD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B9316E-DC7A-274F-4DE3-FB12D6598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40058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EA220-008F-AFD4-7D69-180B8A0FF2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EC6A8-E84B-C7BA-FDDE-B90C42743D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A5FB1A-32B6-27A0-3EFA-51821383B6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AA2FC9-32E8-D220-B1D4-62DBDE8C5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B87E69-519A-FA0F-9B88-0797A513D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123F59-1898-D260-F8F0-6B8CEE236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87949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6BE664-E4AC-EA3C-8C56-1205FFC116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5B3A17-8EF0-557C-922B-0C4C03D9C0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4E78BA-9418-B36B-EF07-2116FA296F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EA699-D16A-C738-FF30-4C9F26DCC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564DD5-C6CA-A68B-B4CF-8EB066922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66DF92-98A6-A60B-52A9-5B8038B23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2229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65807C-03D5-6311-3C79-03D70D72E4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0E8EDB-1CBC-05F5-BFAF-F5F524BB16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6790B7-6996-3C72-0132-CE180F0A4C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7B5109-93D2-44DA-92A6-C31FFCBB2D90}" type="datetimeFigureOut">
              <a:rPr lang="en-ZA" smtClean="0"/>
              <a:t>2023/09/16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352E5F-94C2-99C1-A01C-8CA81D8B97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441A9-8781-6CE6-B4BD-119B7E7230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48650-0DA3-4A8C-B4B9-8ED8EF5FB36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82136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6C3F7A4-A589-EFBA-FD98-13134157F7B0}"/>
              </a:ext>
            </a:extLst>
          </p:cNvPr>
          <p:cNvGrpSpPr/>
          <p:nvPr/>
        </p:nvGrpSpPr>
        <p:grpSpPr>
          <a:xfrm>
            <a:off x="1975862" y="480643"/>
            <a:ext cx="8240275" cy="5287113"/>
            <a:chOff x="1975862" y="785443"/>
            <a:chExt cx="8240275" cy="5287113"/>
          </a:xfrm>
        </p:grpSpPr>
        <p:pic>
          <p:nvPicPr>
            <p:cNvPr id="3" name="Picture 2" descr="A graph with different colored lines&#10;&#10;Description automatically generated">
              <a:extLst>
                <a:ext uri="{FF2B5EF4-FFF2-40B4-BE49-F238E27FC236}">
                  <a16:creationId xmlns:a16="http://schemas.microsoft.com/office/drawing/2014/main" id="{F21727C7-E721-1BC3-3D6D-4D6CB93CF7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5862" y="785443"/>
              <a:ext cx="8240275" cy="5287113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B08827C-CCE7-1CEF-C0F5-2D0A26C43AE4}"/>
                </a:ext>
              </a:extLst>
            </p:cNvPr>
            <p:cNvSpPr txBox="1"/>
            <p:nvPr/>
          </p:nvSpPr>
          <p:spPr>
            <a:xfrm>
              <a:off x="9289772" y="914401"/>
              <a:ext cx="516835" cy="36933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(A)</a:t>
              </a:r>
              <a:endParaRPr lang="en-ZA" b="1" dirty="0"/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B7DA1090-CCC1-5809-C94B-FF09094BB007}"/>
              </a:ext>
            </a:extLst>
          </p:cNvPr>
          <p:cNvSpPr txBox="1"/>
          <p:nvPr/>
        </p:nvSpPr>
        <p:spPr>
          <a:xfrm>
            <a:off x="159026" y="6086207"/>
            <a:ext cx="1184744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1A: Rarefaction plots of 16S amplified sequence variants (ASVs) by sampling depth. JamTomato1 and RoundTomato1: day 1, JamTomato2 and RoundTomato2: day 6 and JamTomato3 and RoundTomato3: day 12</a:t>
            </a:r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3572075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DF37EFF-F387-BF0F-9E82-679F93D4A1F1}"/>
              </a:ext>
            </a:extLst>
          </p:cNvPr>
          <p:cNvGrpSpPr/>
          <p:nvPr/>
        </p:nvGrpSpPr>
        <p:grpSpPr>
          <a:xfrm>
            <a:off x="1976437" y="176211"/>
            <a:ext cx="8239125" cy="5286375"/>
            <a:chOff x="1976437" y="176211"/>
            <a:chExt cx="8239125" cy="528637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0CD85CA-73A1-B411-B532-41322E7A4F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76437" y="176211"/>
              <a:ext cx="8239125" cy="5286375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83FFF64-36A3-60E7-9E6E-1E8B0074ADFD}"/>
                </a:ext>
              </a:extLst>
            </p:cNvPr>
            <p:cNvSpPr txBox="1"/>
            <p:nvPr/>
          </p:nvSpPr>
          <p:spPr>
            <a:xfrm>
              <a:off x="9369285" y="503583"/>
              <a:ext cx="503583" cy="36933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(B)</a:t>
              </a:r>
              <a:endParaRPr lang="en-ZA" b="1" dirty="0"/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C0232DF2-0D3F-4E34-85E7-CCCDF4FB65F4}"/>
              </a:ext>
            </a:extLst>
          </p:cNvPr>
          <p:cNvSpPr txBox="1"/>
          <p:nvPr/>
        </p:nvSpPr>
        <p:spPr>
          <a:xfrm>
            <a:off x="225287" y="5701896"/>
            <a:ext cx="1186069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1B: Rarefaction plots of ITS amplified sequence variants (ASVs) by sampling depth. JamTomato1 and RoundTomato1: day 1, JamTomato2 and RoundTomato2: day 6 and JamTomato3 and RoundTomato3: day 12</a:t>
            </a:r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5358500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30F46C79-FEF6-BC5C-B24D-D220DD00E6CA}"/>
              </a:ext>
            </a:extLst>
          </p:cNvPr>
          <p:cNvGrpSpPr/>
          <p:nvPr/>
        </p:nvGrpSpPr>
        <p:grpSpPr>
          <a:xfrm>
            <a:off x="1683026" y="247470"/>
            <a:ext cx="8189844" cy="5543730"/>
            <a:chOff x="1861124" y="35435"/>
            <a:chExt cx="8011746" cy="6406953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6FB47E2-B12C-D2A6-FAC4-AF0ABBF1FA4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61124" y="35435"/>
              <a:ext cx="8011746" cy="640695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E140E9B-58DC-5915-A2B0-CF5DC5D04FE0}"/>
                </a:ext>
              </a:extLst>
            </p:cNvPr>
            <p:cNvSpPr txBox="1"/>
            <p:nvPr/>
          </p:nvSpPr>
          <p:spPr>
            <a:xfrm>
              <a:off x="2059906" y="106018"/>
              <a:ext cx="5367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(A)</a:t>
              </a:r>
              <a:endParaRPr lang="en-ZA" b="1" dirty="0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3649DD6A-FCA2-57C3-7096-0C59A24D873A}"/>
              </a:ext>
            </a:extLst>
          </p:cNvPr>
          <p:cNvSpPr txBox="1"/>
          <p:nvPr/>
        </p:nvSpPr>
        <p:spPr>
          <a:xfrm>
            <a:off x="145774" y="5960962"/>
            <a:ext cx="1192695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2A: A heatmap showing the relationship in microbial abundance at genus level between Jam and Round over a 12-day storage period for bacteria. The right side of the legend is the </a:t>
            </a:r>
            <a:r>
              <a:rPr lang="en-US" dirty="0" err="1"/>
              <a:t>colour</a:t>
            </a:r>
            <a:r>
              <a:rPr lang="en-US" dirty="0"/>
              <a:t> range with deep blue representing relatively low abundance taxa and the light blue indicating relatively high abundance taxa.</a:t>
            </a:r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16650712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F7ADD83A-2D34-7CC4-E010-7324CBD72406}"/>
              </a:ext>
            </a:extLst>
          </p:cNvPr>
          <p:cNvGrpSpPr/>
          <p:nvPr/>
        </p:nvGrpSpPr>
        <p:grpSpPr>
          <a:xfrm>
            <a:off x="2146851" y="238539"/>
            <a:ext cx="8428383" cy="5208104"/>
            <a:chOff x="1808115" y="92766"/>
            <a:chExt cx="7640685" cy="6110217"/>
          </a:xfrm>
        </p:grpSpPr>
        <p:pic>
          <p:nvPicPr>
            <p:cNvPr id="3" name="Picture 2" descr="A blue and white chart with white text&#10;&#10;Description automatically generated with medium confidence">
              <a:extLst>
                <a:ext uri="{FF2B5EF4-FFF2-40B4-BE49-F238E27FC236}">
                  <a16:creationId xmlns:a16="http://schemas.microsoft.com/office/drawing/2014/main" id="{64002CC3-F34B-791F-6D5D-1EF93F0D5E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8115" y="92766"/>
              <a:ext cx="7640685" cy="6110217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4BFB37-E2D9-39D1-5985-FD6A03A6E458}"/>
                </a:ext>
              </a:extLst>
            </p:cNvPr>
            <p:cNvSpPr txBox="1"/>
            <p:nvPr/>
          </p:nvSpPr>
          <p:spPr>
            <a:xfrm>
              <a:off x="2093845" y="92766"/>
              <a:ext cx="5698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(B)</a:t>
              </a:r>
              <a:endParaRPr lang="en-ZA" b="1" dirty="0"/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584A2663-C666-64AE-E904-32FB038177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477" y="5650947"/>
            <a:ext cx="11687045" cy="1042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6520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1</TotalTime>
  <Words>143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 Abdulsalam (22175907)</dc:creator>
  <cp:lastModifiedBy>MDPI</cp:lastModifiedBy>
  <cp:revision>3</cp:revision>
  <dcterms:created xsi:type="dcterms:W3CDTF">2023-09-09T07:31:48Z</dcterms:created>
  <dcterms:modified xsi:type="dcterms:W3CDTF">2023-09-16T03:48:43Z</dcterms:modified>
</cp:coreProperties>
</file>